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5E5A19-D9C7-460D-B63E-91087EA6DF9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AE4926-CF50-4FFA-B872-284140A2F92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E509E7-F3E6-44A1-9843-A55E3BA89F1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D480C2-65C7-4DF0-8A16-87B40CC0A44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567B7A-0268-4220-98DC-AC6B6DC61E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88B169-5265-4DB0-8D53-E37AF32152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32D2E2-792F-4006-8A6C-EB55E6E0A9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AE5C62-624D-4B16-80D3-167C848143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5D59CE-7F85-4D04-B393-86513106D8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936DEC-330D-4702-8EDE-EC673DB1BA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71AF21-6256-418A-8EF6-18F1713241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5C95AA-28B3-48F5-93CC-CD85AF8F70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442C579-54BF-4703-A290-CF74533501B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1216" t="0" r="0" b="3339"/>
          <a:stretch/>
        </p:blipFill>
        <p:spPr>
          <a:xfrm>
            <a:off x="1177920" y="109440"/>
            <a:ext cx="4557600" cy="184320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 rot="16200000">
            <a:off x="-35640" y="1049400"/>
            <a:ext cx="1425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Normalised Intensit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963360" y="94788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893520" y="50148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858600" y="140652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.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823680" y="5256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788400" y="185112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.0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 rot="16200000">
            <a:off x="2350440" y="639000"/>
            <a:ext cx="118800" cy="2425680"/>
          </a:xfrm>
          <a:custGeom>
            <a:avLst/>
            <a:gdLst>
              <a:gd name="textAreaLeft" fmla="*/ 75960 w 118800"/>
              <a:gd name="textAreaRight" fmla="*/ 119160 w 118800"/>
              <a:gd name="textAreaTop" fmla="*/ 63000 h 2425680"/>
              <a:gd name="textAreaBottom" fmla="*/ 2362680 h 242568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 rot="16200000">
            <a:off x="4636080" y="787680"/>
            <a:ext cx="81000" cy="2082960"/>
          </a:xfrm>
          <a:custGeom>
            <a:avLst/>
            <a:gdLst>
              <a:gd name="textAreaLeft" fmla="*/ 51840 w 81000"/>
              <a:gd name="textAreaRight" fmla="*/ 81000 w 81000"/>
              <a:gd name="textAreaTop" fmla="*/ 54000 h 2082960"/>
              <a:gd name="textAreaBottom" fmla="*/ 2028960 h 20829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2067480" y="1886040"/>
            <a:ext cx="57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ult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4227120" y="1886040"/>
            <a:ext cx="686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Juvenil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200240" y="128520"/>
            <a:ext cx="4521240" cy="18064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" descr=""/>
          <p:cNvPicPr/>
          <p:nvPr/>
        </p:nvPicPr>
        <p:blipFill>
          <a:blip r:embed="rId2"/>
          <a:srcRect l="2957" t="1417" r="0" b="3029"/>
          <a:stretch/>
        </p:blipFill>
        <p:spPr>
          <a:xfrm>
            <a:off x="1174680" y="2217600"/>
            <a:ext cx="4562640" cy="1851120"/>
          </a:xfrm>
          <a:prstGeom prst="rect">
            <a:avLst/>
          </a:prstGeom>
          <a:ln w="0">
            <a:noFill/>
          </a:ln>
        </p:spPr>
      </p:pic>
      <p:sp>
        <p:nvSpPr>
          <p:cNvPr id="54" name=""/>
          <p:cNvSpPr/>
          <p:nvPr/>
        </p:nvSpPr>
        <p:spPr>
          <a:xfrm rot="16200000">
            <a:off x="-35640" y="7598520"/>
            <a:ext cx="1425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Normalised Intensit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rot="16200000">
            <a:off x="1977120" y="3205800"/>
            <a:ext cx="69840" cy="1569960"/>
          </a:xfrm>
          <a:custGeom>
            <a:avLst/>
            <a:gdLst>
              <a:gd name="textAreaLeft" fmla="*/ 44640 w 69840"/>
              <a:gd name="textAreaRight" fmla="*/ 69840 w 69840"/>
              <a:gd name="textAreaTop" fmla="*/ 40680 h 1569960"/>
              <a:gd name="textAreaBottom" fmla="*/ 1529280 h 15699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rot="16200000">
            <a:off x="3840840" y="3634560"/>
            <a:ext cx="69840" cy="712800"/>
          </a:xfrm>
          <a:custGeom>
            <a:avLst/>
            <a:gdLst>
              <a:gd name="textAreaLeft" fmla="*/ 44640 w 69840"/>
              <a:gd name="textAreaRight" fmla="*/ 69840 w 69840"/>
              <a:gd name="textAreaTop" fmla="*/ 18360 h 712800"/>
              <a:gd name="textAreaBottom" fmla="*/ 694440 h 7128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rot="16200000">
            <a:off x="4551480" y="3703680"/>
            <a:ext cx="69840" cy="574560"/>
          </a:xfrm>
          <a:custGeom>
            <a:avLst/>
            <a:gdLst>
              <a:gd name="textAreaLeft" fmla="*/ 44640 w 69840"/>
              <a:gd name="textAreaRight" fmla="*/ 69840 w 69840"/>
              <a:gd name="textAreaTop" fmla="*/ 14760 h 574560"/>
              <a:gd name="textAreaBottom" fmla="*/ 559800 h 5745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rot="16200000">
            <a:off x="5313240" y="3608280"/>
            <a:ext cx="44640" cy="739800"/>
          </a:xfrm>
          <a:custGeom>
            <a:avLst/>
            <a:gdLst>
              <a:gd name="textAreaLeft" fmla="*/ 28440 w 44640"/>
              <a:gd name="textAreaRight" fmla="*/ 45000 w 44640"/>
              <a:gd name="textAreaTop" fmla="*/ 19080 h 739800"/>
              <a:gd name="textAreaBottom" fmla="*/ 720720 h 7398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860480" y="403056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2955600" y="403056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671640" y="403056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4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4371840" y="403056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4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5114520" y="403056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2820960" y="4140360"/>
            <a:ext cx="1863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admium [mgkg</a:t>
            </a:r>
            <a:r>
              <a:rPr b="1" lang="en-US" sz="1000" spc="-1" strike="noStrike" baseline="30000">
                <a:solidFill>
                  <a:srgbClr val="000000"/>
                </a:solidFill>
                <a:latin typeface="Arial"/>
              </a:rPr>
              <a:t>-1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]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 rot="16200000">
            <a:off x="3108240" y="3703680"/>
            <a:ext cx="69840" cy="574560"/>
          </a:xfrm>
          <a:custGeom>
            <a:avLst/>
            <a:gdLst>
              <a:gd name="textAreaLeft" fmla="*/ 44640 w 69840"/>
              <a:gd name="textAreaRight" fmla="*/ 69840 w 69840"/>
              <a:gd name="textAreaTop" fmla="*/ 14760 h 574560"/>
              <a:gd name="textAreaBottom" fmla="*/ 559800 h 5745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963360" y="300528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893520" y="255888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858600" y="346392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.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823680" y="210996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788400" y="390852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.0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1" name="" descr=""/>
          <p:cNvPicPr/>
          <p:nvPr/>
        </p:nvPicPr>
        <p:blipFill>
          <a:blip r:embed="rId3"/>
          <a:srcRect l="3849" t="1457" r="0" b="6208"/>
          <a:stretch/>
        </p:blipFill>
        <p:spPr>
          <a:xfrm>
            <a:off x="1219320" y="4405320"/>
            <a:ext cx="4505040" cy="1871640"/>
          </a:xfrm>
          <a:prstGeom prst="rect">
            <a:avLst/>
          </a:prstGeom>
          <a:ln w="0">
            <a:noFill/>
          </a:ln>
        </p:spPr>
      </p:pic>
      <p:sp>
        <p:nvSpPr>
          <p:cNvPr id="72" name=""/>
          <p:cNvSpPr/>
          <p:nvPr/>
        </p:nvSpPr>
        <p:spPr>
          <a:xfrm>
            <a:off x="1241280" y="4392720"/>
            <a:ext cx="4508640" cy="1933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rot="16200000">
            <a:off x="1865880" y="5507280"/>
            <a:ext cx="135000" cy="1396800"/>
          </a:xfrm>
          <a:custGeom>
            <a:avLst/>
            <a:gdLst>
              <a:gd name="textAreaLeft" fmla="*/ 86400 w 135000"/>
              <a:gd name="textAreaRight" fmla="*/ 135360 w 135000"/>
              <a:gd name="textAreaTop" fmla="*/ 36360 h 1396800"/>
              <a:gd name="textAreaBottom" fmla="*/ 1360440 h 13968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 rot="16200000">
            <a:off x="3803400" y="5820840"/>
            <a:ext cx="122040" cy="782640"/>
          </a:xfrm>
          <a:custGeom>
            <a:avLst/>
            <a:gdLst>
              <a:gd name="textAreaLeft" fmla="*/ 78120 w 122040"/>
              <a:gd name="textAreaRight" fmla="*/ 122040 w 122040"/>
              <a:gd name="textAreaTop" fmla="*/ 20160 h 782640"/>
              <a:gd name="textAreaBottom" fmla="*/ 762480 h 7826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 rot="16200000">
            <a:off x="4530600" y="5887440"/>
            <a:ext cx="111240" cy="657360"/>
          </a:xfrm>
          <a:custGeom>
            <a:avLst/>
            <a:gdLst>
              <a:gd name="textAreaLeft" fmla="*/ 71280 w 111240"/>
              <a:gd name="textAreaRight" fmla="*/ 111600 w 111240"/>
              <a:gd name="textAreaTop" fmla="*/ 16920 h 657360"/>
              <a:gd name="textAreaBottom" fmla="*/ 640440 h 6573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 rot="16200000">
            <a:off x="5276160" y="5814000"/>
            <a:ext cx="122040" cy="796680"/>
          </a:xfrm>
          <a:custGeom>
            <a:avLst/>
            <a:gdLst>
              <a:gd name="textAreaLeft" fmla="*/ 78120 w 122040"/>
              <a:gd name="textAreaRight" fmla="*/ 122040 w 122040"/>
              <a:gd name="textAreaTop" fmla="*/ 20520 h 796680"/>
              <a:gd name="textAreaBottom" fmla="*/ 776160 h 79668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1817640" y="62802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2927160" y="628020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3740040" y="628020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4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4427280" y="628020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5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5179680" y="628020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55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2781360" y="6419880"/>
            <a:ext cx="1990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Fluoranthene [mgkg</a:t>
            </a:r>
            <a:r>
              <a:rPr b="1" lang="en-GB" sz="1000" spc="-1" strike="noStrike" baseline="30000">
                <a:solidFill>
                  <a:srgbClr val="000000"/>
                </a:solidFill>
                <a:latin typeface="Arial"/>
              </a:rPr>
              <a:t>-1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]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 rot="16200000">
            <a:off x="3002040" y="5838840"/>
            <a:ext cx="87120" cy="782640"/>
          </a:xfrm>
          <a:custGeom>
            <a:avLst/>
            <a:gdLst>
              <a:gd name="textAreaLeft" fmla="*/ 55800 w 87120"/>
              <a:gd name="textAreaRight" fmla="*/ 87480 w 87120"/>
              <a:gd name="textAreaTop" fmla="*/ 20160 h 782640"/>
              <a:gd name="textAreaBottom" fmla="*/ 762480 h 7826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963360" y="522144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893520" y="477504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858600" y="568008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.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823680" y="432576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788400" y="612468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.0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9" name="" descr=""/>
          <p:cNvPicPr/>
          <p:nvPr/>
        </p:nvPicPr>
        <p:blipFill>
          <a:blip r:embed="rId4"/>
          <a:srcRect l="3813" t="0" r="0" b="4325"/>
          <a:stretch/>
        </p:blipFill>
        <p:spPr>
          <a:xfrm>
            <a:off x="1190520" y="6670800"/>
            <a:ext cx="4560840" cy="2014560"/>
          </a:xfrm>
          <a:prstGeom prst="rect">
            <a:avLst/>
          </a:prstGeom>
          <a:ln w="0">
            <a:noFill/>
          </a:ln>
        </p:spPr>
      </p:pic>
      <p:sp>
        <p:nvSpPr>
          <p:cNvPr id="90" name=""/>
          <p:cNvSpPr/>
          <p:nvPr/>
        </p:nvSpPr>
        <p:spPr>
          <a:xfrm>
            <a:off x="1214280" y="6683400"/>
            <a:ext cx="4546800" cy="1990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 rot="16200000">
            <a:off x="1825560" y="7916760"/>
            <a:ext cx="123840" cy="1339920"/>
          </a:xfrm>
          <a:custGeom>
            <a:avLst/>
            <a:gdLst>
              <a:gd name="textAreaLeft" fmla="*/ 79200 w 123840"/>
              <a:gd name="textAreaRight" fmla="*/ 124200 w 123840"/>
              <a:gd name="textAreaTop" fmla="*/ 34920 h 1339920"/>
              <a:gd name="textAreaBottom" fmla="*/ 1305000 h 13399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 rot="16200000">
            <a:off x="3687120" y="8190360"/>
            <a:ext cx="122040" cy="793800"/>
          </a:xfrm>
          <a:custGeom>
            <a:avLst/>
            <a:gdLst>
              <a:gd name="textAreaLeft" fmla="*/ 78120 w 122040"/>
              <a:gd name="textAreaRight" fmla="*/ 122040 w 122040"/>
              <a:gd name="textAreaTop" fmla="*/ 20520 h 793800"/>
              <a:gd name="textAreaBottom" fmla="*/ 773280 h 7938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 rot="16200000">
            <a:off x="4479120" y="8214480"/>
            <a:ext cx="100080" cy="720720"/>
          </a:xfrm>
          <a:custGeom>
            <a:avLst/>
            <a:gdLst>
              <a:gd name="textAreaLeft" fmla="*/ 64080 w 100080"/>
              <a:gd name="textAreaRight" fmla="*/ 100440 w 100080"/>
              <a:gd name="textAreaTop" fmla="*/ 18720 h 720720"/>
              <a:gd name="textAreaBottom" fmla="*/ 702000 h 7207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 rot="16200000">
            <a:off x="5237280" y="8206920"/>
            <a:ext cx="122040" cy="785880"/>
          </a:xfrm>
          <a:custGeom>
            <a:avLst/>
            <a:gdLst>
              <a:gd name="textAreaLeft" fmla="*/ 78120 w 122040"/>
              <a:gd name="textAreaRight" fmla="*/ 122040 w 122040"/>
              <a:gd name="textAreaTop" fmla="*/ 20160 h 785880"/>
              <a:gd name="textAreaBottom" fmla="*/ 765720 h 78588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1792080" y="86328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2857320" y="86328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3603600" y="863280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4365360" y="863280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3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5173560" y="863280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5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2833560" y="8823240"/>
            <a:ext cx="1660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Atrazine [mgkg</a:t>
            </a:r>
            <a:r>
              <a:rPr b="1" lang="en-GB" sz="1000" spc="-1" strike="noStrike" baseline="30000">
                <a:solidFill>
                  <a:srgbClr val="000000"/>
                </a:solidFill>
                <a:latin typeface="Arial"/>
              </a:rPr>
              <a:t>-1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]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 rot="16200000">
            <a:off x="2917080" y="8201520"/>
            <a:ext cx="98280" cy="772920"/>
          </a:xfrm>
          <a:custGeom>
            <a:avLst/>
            <a:gdLst>
              <a:gd name="textAreaLeft" fmla="*/ 63000 w 98280"/>
              <a:gd name="textAreaRight" fmla="*/ 98640 w 98280"/>
              <a:gd name="textAreaTop" fmla="*/ 20160 h 772920"/>
              <a:gd name="textAreaBottom" fmla="*/ 752760 h 7729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1200240" y="2165400"/>
            <a:ext cx="4508280" cy="18921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963360" y="75852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893520" y="710712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858600" y="804384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.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823680" y="662004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788400" y="8545680"/>
            <a:ext cx="42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.0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 rot="16200000">
            <a:off x="-35640" y="5267520"/>
            <a:ext cx="1425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Normalised Intensit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 rot="16200000">
            <a:off x="-35640" y="2992680"/>
            <a:ext cx="1425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Normalised Intensit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293400" y="14400"/>
            <a:ext cx="358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293400" y="2058840"/>
            <a:ext cx="358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293400" y="4200480"/>
            <a:ext cx="358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293400" y="6616800"/>
            <a:ext cx="358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D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9-14T16:23:14Z</dcterms:created>
  <dc:creator>smbpk</dc:creator>
  <dc:description/>
  <dc:language>en-US</dc:language>
  <cp:lastModifiedBy>smbpk</cp:lastModifiedBy>
  <dcterms:modified xsi:type="dcterms:W3CDTF">2007-09-14T16:45:56Z</dcterms:modified>
  <cp:revision>2</cp:revision>
  <dc:subject/>
  <dc:title>Slide 1</dc:title>
</cp:coreProperties>
</file>